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9144000" cy="6858000" type="screen4x3"/>
  <p:notesSz cx="6735763" cy="9866313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861" autoAdjust="0"/>
    <p:restoredTop sz="94660"/>
  </p:normalViewPr>
  <p:slideViewPr>
    <p:cSldViewPr>
      <p:cViewPr varScale="1">
        <p:scale>
          <a:sx n="69" d="100"/>
          <a:sy n="69" d="100"/>
        </p:scale>
        <p:origin x="-132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25" tIns="45713" rIns="91425" bIns="45713" rtlCol="0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3815374" y="0"/>
            <a:ext cx="2918831" cy="493316"/>
          </a:xfrm>
          <a:prstGeom prst="rect">
            <a:avLst/>
          </a:prstGeom>
        </p:spPr>
        <p:txBody>
          <a:bodyPr vert="horz" lIns="91425" tIns="45713" rIns="91425" bIns="45713" rtlCol="0"/>
          <a:lstStyle>
            <a:lvl1pPr algn="r">
              <a:defRPr sz="1200"/>
            </a:lvl1pPr>
          </a:lstStyle>
          <a:p>
            <a:fld id="{24B17DEB-0904-4369-A6EA-ACB00E3A52A9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901700" y="739775"/>
            <a:ext cx="4932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5" tIns="45713" rIns="91425" bIns="45713" rtlCol="0" anchor="ctr"/>
          <a:lstStyle/>
          <a:p>
            <a:endParaRPr lang="ru-RU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1425" tIns="45713" rIns="91425" bIns="45713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25" tIns="45713" rIns="91425" bIns="45713" rtlCol="0" anchor="b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3815374" y="9371285"/>
            <a:ext cx="2918831" cy="493316"/>
          </a:xfrm>
          <a:prstGeom prst="rect">
            <a:avLst/>
          </a:prstGeom>
        </p:spPr>
        <p:txBody>
          <a:bodyPr vert="horz" lIns="91425" tIns="45713" rIns="91425" bIns="45713" rtlCol="0" anchor="b"/>
          <a:lstStyle>
            <a:lvl1pPr algn="r">
              <a:defRPr sz="1200"/>
            </a:lvl1pPr>
          </a:lstStyle>
          <a:p>
            <a:fld id="{27C71963-4059-4562-914A-FF42F7120A56}" type="slidenum">
              <a:rPr lang="ru-RU" smtClean="0"/>
              <a:pPr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Образ слайда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Заметки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C71963-4059-4562-914A-FF42F7120A56}" type="slidenum">
              <a:rPr lang="ru-RU" smtClean="0"/>
              <a:pPr/>
              <a:t>1</a:t>
            </a:fld>
            <a:endParaRPr lang="ru-RU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Прямоугольник 2"/>
          <p:cNvSpPr/>
          <p:nvPr/>
        </p:nvSpPr>
        <p:spPr>
          <a:xfrm>
            <a:off x="5940152" y="2564904"/>
            <a:ext cx="2736304" cy="19543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Fig.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S4.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YB-1 transcription initiation region studied by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HeliScopeCAGE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(Forrest et al., 2014; Nature). Data for several selected cell types are shown. The minor TSSs in the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intronic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region show visible activity. The X axis corresponds to the genomic coordinates with the gene structure shown at the top panel. The height of the bars is proportional to the number of mRNAs transcribed from a particular position.</a:t>
            </a:r>
            <a:endParaRPr lang="ru-RU" sz="11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7" name="Picture 3" descr="\\195.19.5.112\lev\Lab_Publications\2013_Lyabin_5'UTR\PlosOne\final\After revision\S4.pn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07504" y="332656"/>
            <a:ext cx="5400600" cy="6131499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13</TotalTime>
  <Words>77</Words>
  <Application>Microsoft Office PowerPoint</Application>
  <PresentationFormat>Экран (4:3)</PresentationFormat>
  <Paragraphs>2</Paragraphs>
  <Slides>1</Slides>
  <Notes>1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Слайд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Слайд 1</dc:title>
  <dc:creator>Lyabin</dc:creator>
  <cp:lastModifiedBy>Admin</cp:lastModifiedBy>
  <cp:revision>127</cp:revision>
  <dcterms:created xsi:type="dcterms:W3CDTF">2012-07-09T09:21:16Z</dcterms:created>
  <dcterms:modified xsi:type="dcterms:W3CDTF">2014-07-17T09:14:24Z</dcterms:modified>
</cp:coreProperties>
</file>